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446" autoAdjust="0"/>
    <p:restoredTop sz="94660"/>
  </p:normalViewPr>
  <p:slideViewPr>
    <p:cSldViewPr snapToGrid="0">
      <p:cViewPr>
        <p:scale>
          <a:sx n="76" d="100"/>
          <a:sy n="76" d="100"/>
        </p:scale>
        <p:origin x="-29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8D2BC2-9590-6243-9933-B4C5EC06FA2C}" type="datetimeFigureOut">
              <a:rPr kumimoji="1" lang="ko-KR" altLang="en-US" smtClean="0"/>
              <a:t>2019. 2. 22.</a:t>
            </a:fld>
            <a:endParaRPr kumimoji="1"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 smtClean="0"/>
              <a:t>마스터 텍스트 스타일을 편집하려면 클릭</a:t>
            </a:r>
          </a:p>
          <a:p>
            <a:pPr lvl="1"/>
            <a:r>
              <a:rPr kumimoji="1" lang="ko-KR" altLang="en-US" smtClean="0"/>
              <a:t>두 번째 수준</a:t>
            </a:r>
          </a:p>
          <a:p>
            <a:pPr lvl="2"/>
            <a:r>
              <a:rPr kumimoji="1" lang="ko-KR" altLang="en-US" smtClean="0"/>
              <a:t>세 번째 수준</a:t>
            </a:r>
          </a:p>
          <a:p>
            <a:pPr lvl="3"/>
            <a:r>
              <a:rPr kumimoji="1" lang="ko-KR" altLang="en-US" smtClean="0"/>
              <a:t>네 번째 수준</a:t>
            </a:r>
          </a:p>
          <a:p>
            <a:pPr lvl="4"/>
            <a:r>
              <a:rPr kumimoji="1" lang="ko-KR" altLang="en-US" smtClean="0"/>
              <a:t>다섯 번째 수준</a:t>
            </a:r>
            <a:endParaRPr kumimoji="1"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AFA6E-B8AA-C342-B43E-363191C78AC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4723479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3067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02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066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0867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5173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3031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2274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77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1269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3129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3792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945F28-D90E-494E-8C5C-95B2310C8387}" type="datetimeFigureOut">
              <a:rPr lang="ko-KR" altLang="en-US" smtClean="0"/>
              <a:t>2019. 2. 22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5E7CB0-D83E-48DB-97CC-14ED539AF4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0042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4750054"/>
              </p:ext>
            </p:extLst>
          </p:nvPr>
        </p:nvGraphicFramePr>
        <p:xfrm>
          <a:off x="2191921" y="1395684"/>
          <a:ext cx="7169150" cy="3909187"/>
        </p:xfrm>
        <a:graphic>
          <a:graphicData uri="http://schemas.openxmlformats.org/drawingml/2006/table">
            <a:tbl>
              <a:tblPr firstRow="1" bandRow="1"/>
              <a:tblGrid>
                <a:gridCol w="115633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77806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833717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421106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35001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629920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</a:tblGrid>
              <a:tr h="22606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otal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PV E6/E7 negative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PV E6/E7 positive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i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value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0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1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ge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≥ 50s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8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 (88.9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0 (35.1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&lt; 50s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 (11.1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1 (64.9)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26060">
                <a:tc rowSpan="5"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ace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hite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7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 (55.6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2 (65.5)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8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26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lack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 (11.1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 (10.5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3558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sian and pacific islander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 (11.1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 (7.0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26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merican Indian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 (0.0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 (1.2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4607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Unknown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9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 (22.2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 (15.8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istology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denocarcinoma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0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 (44.4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6 (15.2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deno-squamous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 (22.2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 (1.2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3558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quamous cell carcinoma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6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 (33.3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3 (83.6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GO stage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≥ IIB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3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 (44.4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9 (40.4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9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&lt; IIB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2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 (55.6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7 (56.7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Unknown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 (0.0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 (2.9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1286262" y="4468887"/>
            <a:ext cx="6787134" cy="11230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112" tIns="914112" rIns="914112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CGA, The Cancer Genome Atlas; FIGO, International Federation of Gynecology.</a:t>
            </a:r>
          </a:p>
        </p:txBody>
      </p:sp>
      <p:sp>
        <p:nvSpPr>
          <p:cNvPr id="8" name="직사각형 7"/>
          <p:cNvSpPr/>
          <p:nvPr/>
        </p:nvSpPr>
        <p:spPr>
          <a:xfrm>
            <a:off x="2095398" y="1084597"/>
            <a:ext cx="30844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0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ko-KR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z="10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inical information from TCGA data</a:t>
            </a:r>
            <a:endParaRPr kumimoji="0" lang="en-US" altLang="ko-KR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353804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2</TotalTime>
  <Words>185</Words>
  <Application>Microsoft Macintosh PowerPoint</Application>
  <PresentationFormat>와이드스크린</PresentationFormat>
  <Paragraphs>6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Microsoft Office 사용자</cp:lastModifiedBy>
  <cp:revision>20</cp:revision>
  <dcterms:created xsi:type="dcterms:W3CDTF">2018-01-02T07:02:14Z</dcterms:created>
  <dcterms:modified xsi:type="dcterms:W3CDTF">2019-02-21T15:05:44Z</dcterms:modified>
</cp:coreProperties>
</file>